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52" d="100"/>
          <a:sy n="52" d="100"/>
        </p:scale>
        <p:origin x="221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37786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48309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7081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288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26328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44282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03108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07024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17353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20092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41870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60973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tângulo 6"/>
          <p:cNvSpPr/>
          <p:nvPr/>
        </p:nvSpPr>
        <p:spPr>
          <a:xfrm>
            <a:off x="0" y="5435288"/>
            <a:ext cx="6858000" cy="1154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tabLst>
                <a:tab pos="3002893" algn="l"/>
              </a:tabLst>
            </a:pPr>
            <a:r>
              <a:rPr lang="en-US" sz="1200" b="1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.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onships between photosynthesis (</a:t>
            </a:r>
            <a:r>
              <a:rPr lang="en-US" sz="1200" i="1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tal chlorophyll </a:t>
            </a:r>
            <a:r>
              <a:rPr lang="en-US" sz="1200" b="1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b="1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)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protein content </a:t>
            </a:r>
            <a:r>
              <a:rPr lang="en-US" sz="1200" b="1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 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b="1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)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4-week-old plants from two ILs of </a:t>
            </a:r>
            <a:r>
              <a:rPr lang="en-US" sz="1200" i="1" kern="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kern="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nnellii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to a genetic background of </a:t>
            </a:r>
            <a:r>
              <a:rPr lang="en-US" sz="1200" i="1" kern="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kern="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copersicum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M82) grown at 400 and at 800 µ</a:t>
            </a:r>
            <a:r>
              <a:rPr lang="en-US" sz="1200" kern="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</a:t>
            </a:r>
            <a:r>
              <a:rPr lang="en-US" sz="1200" kern="0" baseline="-2500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l</a:t>
            </a:r>
            <a:r>
              <a:rPr lang="en-US" sz="1200" kern="0" baseline="3000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ir. </a:t>
            </a:r>
            <a:r>
              <a:rPr lang="en-US" sz="12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ach point represents biological replicate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determination coefficien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W: Fresh weight.</a:t>
            </a:r>
            <a:endParaRPr lang="pt-B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tabLst>
                <a:tab pos="3002893" algn="l"/>
              </a:tabLst>
            </a:pPr>
            <a:endParaRPr lang="pt-B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7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t-BR"/>
          </a:p>
        </p:txBody>
      </p:sp>
      <p:pic>
        <p:nvPicPr>
          <p:cNvPr id="8" name="Imagem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705650" cy="5216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74796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80</TotalTime>
  <Words>73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liente</dc:creator>
  <cp:lastModifiedBy>Cliente</cp:lastModifiedBy>
  <cp:revision>26</cp:revision>
  <dcterms:created xsi:type="dcterms:W3CDTF">2019-04-29T12:03:19Z</dcterms:created>
  <dcterms:modified xsi:type="dcterms:W3CDTF">2020-05-01T01:20:59Z</dcterms:modified>
</cp:coreProperties>
</file>